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4" r:id="rId3"/>
    <p:sldId id="26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5649F24-7872-8A42-8133-18150F622A70}" v="51" dt="2025-04-17T07:34:30.11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rley Chang" userId="119bcda2-c8fb-4353-851b-58d2ee082112" providerId="ADAL" clId="{F9CA84EA-86E2-D54F-9901-205D0B1EA2A5}"/>
    <pc:docChg chg="modSld">
      <pc:chgData name="Shirley Chang" userId="119bcda2-c8fb-4353-851b-58d2ee082112" providerId="ADAL" clId="{F9CA84EA-86E2-D54F-9901-205D0B1EA2A5}" dt="2024-12-19T01:14:10.799" v="5" actId="164"/>
      <pc:docMkLst>
        <pc:docMk/>
      </pc:docMkLst>
      <pc:sldChg chg="addSp modSp mod">
        <pc:chgData name="Shirley Chang" userId="119bcda2-c8fb-4353-851b-58d2ee082112" providerId="ADAL" clId="{F9CA84EA-86E2-D54F-9901-205D0B1EA2A5}" dt="2024-12-19T01:14:10.799" v="5" actId="164"/>
        <pc:sldMkLst>
          <pc:docMk/>
          <pc:sldMk cId="1288760415" sldId="264"/>
        </pc:sldMkLst>
        <pc:grpChg chg="add mod">
          <ac:chgData name="Shirley Chang" userId="119bcda2-c8fb-4353-851b-58d2ee082112" providerId="ADAL" clId="{F9CA84EA-86E2-D54F-9901-205D0B1EA2A5}" dt="2024-12-19T01:13:50.809" v="1" actId="164"/>
          <ac:grpSpMkLst>
            <pc:docMk/>
            <pc:sldMk cId="1288760415" sldId="264"/>
            <ac:grpSpMk id="2" creationId="{94FEB592-0724-AD59-5BF2-9658915BDEAD}"/>
          </ac:grpSpMkLst>
        </pc:grpChg>
        <pc:grpChg chg="add mod">
          <ac:chgData name="Shirley Chang" userId="119bcda2-c8fb-4353-851b-58d2ee082112" providerId="ADAL" clId="{F9CA84EA-86E2-D54F-9901-205D0B1EA2A5}" dt="2024-12-19T01:14:10.799" v="5" actId="164"/>
          <ac:grpSpMkLst>
            <pc:docMk/>
            <pc:sldMk cId="1288760415" sldId="264"/>
            <ac:grpSpMk id="3" creationId="{837C2EAF-F7F9-9478-4FE4-09288D5CF20B}"/>
          </ac:grpSpMkLst>
        </pc:grpChg>
        <pc:picChg chg="mod">
          <ac:chgData name="Shirley Chang" userId="119bcda2-c8fb-4353-851b-58d2ee082112" providerId="ADAL" clId="{F9CA84EA-86E2-D54F-9901-205D0B1EA2A5}" dt="2024-12-19T01:14:10.799" v="5" actId="164"/>
          <ac:picMkLst>
            <pc:docMk/>
            <pc:sldMk cId="1288760415" sldId="264"/>
            <ac:picMk id="9" creationId="{6756C74A-49E1-F25F-AEFA-10A8A6032821}"/>
          </ac:picMkLst>
        </pc:picChg>
        <pc:picChg chg="mod">
          <ac:chgData name="Shirley Chang" userId="119bcda2-c8fb-4353-851b-58d2ee082112" providerId="ADAL" clId="{F9CA84EA-86E2-D54F-9901-205D0B1EA2A5}" dt="2024-12-19T01:14:10.799" v="5" actId="164"/>
          <ac:picMkLst>
            <pc:docMk/>
            <pc:sldMk cId="1288760415" sldId="264"/>
            <ac:picMk id="10" creationId="{E9F912E4-E594-732D-07D1-7843D26046C1}"/>
          </ac:picMkLst>
        </pc:picChg>
        <pc:picChg chg="mod">
          <ac:chgData name="Shirley Chang" userId="119bcda2-c8fb-4353-851b-58d2ee082112" providerId="ADAL" clId="{F9CA84EA-86E2-D54F-9901-205D0B1EA2A5}" dt="2024-12-19T01:14:10.799" v="5" actId="164"/>
          <ac:picMkLst>
            <pc:docMk/>
            <pc:sldMk cId="1288760415" sldId="264"/>
            <ac:picMk id="11" creationId="{AD63F7DD-8FC8-9F00-84FE-578E656E24D9}"/>
          </ac:picMkLst>
        </pc:picChg>
        <pc:picChg chg="mod">
          <ac:chgData name="Shirley Chang" userId="119bcda2-c8fb-4353-851b-58d2ee082112" providerId="ADAL" clId="{F9CA84EA-86E2-D54F-9901-205D0B1EA2A5}" dt="2024-12-19T01:14:10.799" v="5" actId="164"/>
          <ac:picMkLst>
            <pc:docMk/>
            <pc:sldMk cId="1288760415" sldId="264"/>
            <ac:picMk id="12" creationId="{B117B72C-B9EF-1CB9-6332-C65063B26A58}"/>
          </ac:picMkLst>
        </pc:picChg>
      </pc:sldChg>
    </pc:docChg>
  </pc:docChgLst>
  <pc:docChgLst>
    <pc:chgData name="Shirley Chang" userId="119bcda2-c8fb-4353-851b-58d2ee082112" providerId="ADAL" clId="{8CCD629D-F3E0-1E40-91F1-70AE4173786F}"/>
    <pc:docChg chg="undo custSel addSld delSld modSld">
      <pc:chgData name="Shirley Chang" userId="119bcda2-c8fb-4353-851b-58d2ee082112" providerId="ADAL" clId="{8CCD629D-F3E0-1E40-91F1-70AE4173786F}" dt="2024-12-04T10:49:26.371" v="148" actId="2696"/>
      <pc:docMkLst>
        <pc:docMk/>
      </pc:docMkLst>
      <pc:sldChg chg="addSp delSp modSp del mod">
        <pc:chgData name="Shirley Chang" userId="119bcda2-c8fb-4353-851b-58d2ee082112" providerId="ADAL" clId="{8CCD629D-F3E0-1E40-91F1-70AE4173786F}" dt="2024-12-04T04:58:24.626" v="119" actId="2696"/>
        <pc:sldMkLst>
          <pc:docMk/>
          <pc:sldMk cId="2087539260" sldId="257"/>
        </pc:sldMkLst>
      </pc:sldChg>
      <pc:sldChg chg="addSp modSp mod">
        <pc:chgData name="Shirley Chang" userId="119bcda2-c8fb-4353-851b-58d2ee082112" providerId="ADAL" clId="{8CCD629D-F3E0-1E40-91F1-70AE4173786F}" dt="2024-12-04T05:47:57.044" v="141" actId="2711"/>
        <pc:sldMkLst>
          <pc:docMk/>
          <pc:sldMk cId="3847332793" sldId="260"/>
        </pc:sldMkLst>
        <pc:spChg chg="mod">
          <ac:chgData name="Shirley Chang" userId="119bcda2-c8fb-4353-851b-58d2ee082112" providerId="ADAL" clId="{8CCD629D-F3E0-1E40-91F1-70AE4173786F}" dt="2024-12-04T05:47:57.044" v="141" actId="2711"/>
          <ac:spMkLst>
            <pc:docMk/>
            <pc:sldMk cId="3847332793" sldId="260"/>
            <ac:spMk id="4" creationId="{5B5F7517-350F-0407-CBB6-34086BED3754}"/>
          </ac:spMkLst>
        </pc:spChg>
        <pc:spChg chg="mod">
          <ac:chgData name="Shirley Chang" userId="119bcda2-c8fb-4353-851b-58d2ee082112" providerId="ADAL" clId="{8CCD629D-F3E0-1E40-91F1-70AE4173786F}" dt="2024-12-04T04:53:24.461" v="76" actId="1076"/>
          <ac:spMkLst>
            <pc:docMk/>
            <pc:sldMk cId="3847332793" sldId="260"/>
            <ac:spMk id="9" creationId="{33696138-C610-B74F-99B0-9B192F79A4B1}"/>
          </ac:spMkLst>
        </pc:spChg>
        <pc:spChg chg="mod">
          <ac:chgData name="Shirley Chang" userId="119bcda2-c8fb-4353-851b-58d2ee082112" providerId="ADAL" clId="{8CCD629D-F3E0-1E40-91F1-70AE4173786F}" dt="2024-12-04T05:00:13.332" v="134" actId="1076"/>
          <ac:spMkLst>
            <pc:docMk/>
            <pc:sldMk cId="3847332793" sldId="260"/>
            <ac:spMk id="10" creationId="{6330F99C-EBBE-D41E-55BA-4D1CC537D92F}"/>
          </ac:spMkLst>
        </pc:spChg>
        <pc:spChg chg="mod">
          <ac:chgData name="Shirley Chang" userId="119bcda2-c8fb-4353-851b-58d2ee082112" providerId="ADAL" clId="{8CCD629D-F3E0-1E40-91F1-70AE4173786F}" dt="2024-12-04T04:54:37.929" v="86" actId="1076"/>
          <ac:spMkLst>
            <pc:docMk/>
            <pc:sldMk cId="3847332793" sldId="260"/>
            <ac:spMk id="11" creationId="{80682AA1-C55C-6AC7-6385-0B6927EED112}"/>
          </ac:spMkLst>
        </pc:spChg>
        <pc:spChg chg="mod">
          <ac:chgData name="Shirley Chang" userId="119bcda2-c8fb-4353-851b-58d2ee082112" providerId="ADAL" clId="{8CCD629D-F3E0-1E40-91F1-70AE4173786F}" dt="2024-12-04T04:55:26.014" v="97" actId="1076"/>
          <ac:spMkLst>
            <pc:docMk/>
            <pc:sldMk cId="3847332793" sldId="260"/>
            <ac:spMk id="12" creationId="{01C9FE6E-5593-8429-6FB2-C1D140897655}"/>
          </ac:spMkLst>
        </pc:spChg>
        <pc:grpChg chg="add mod">
          <ac:chgData name="Shirley Chang" userId="119bcda2-c8fb-4353-851b-58d2ee082112" providerId="ADAL" clId="{8CCD629D-F3E0-1E40-91F1-70AE4173786F}" dt="2024-12-04T04:59:44.183" v="133" actId="1037"/>
          <ac:grpSpMkLst>
            <pc:docMk/>
            <pc:sldMk cId="3847332793" sldId="260"/>
            <ac:grpSpMk id="2" creationId="{C49EECFC-ECD3-178F-560D-D2B58F56D6A3}"/>
          </ac:grpSpMkLst>
        </pc:grpChg>
        <pc:grpChg chg="add mod">
          <ac:chgData name="Shirley Chang" userId="119bcda2-c8fb-4353-851b-58d2ee082112" providerId="ADAL" clId="{8CCD629D-F3E0-1E40-91F1-70AE4173786F}" dt="2024-12-04T05:10:38.868" v="136" actId="1076"/>
          <ac:grpSpMkLst>
            <pc:docMk/>
            <pc:sldMk cId="3847332793" sldId="260"/>
            <ac:grpSpMk id="3" creationId="{28773F12-D66E-D721-7FB1-CAA6DAF4F8D8}"/>
          </ac:grpSpMkLst>
        </pc:grpChg>
        <pc:picChg chg="mod">
          <ac:chgData name="Shirley Chang" userId="119bcda2-c8fb-4353-851b-58d2ee082112" providerId="ADAL" clId="{8CCD629D-F3E0-1E40-91F1-70AE4173786F}" dt="2024-12-04T04:50:02.139" v="16"/>
          <ac:picMkLst>
            <pc:docMk/>
            <pc:sldMk cId="3847332793" sldId="260"/>
            <ac:picMk id="5" creationId="{94337381-1927-78F1-FDF7-64033AE72BC0}"/>
          </ac:picMkLst>
        </pc:picChg>
        <pc:picChg chg="mod">
          <ac:chgData name="Shirley Chang" userId="119bcda2-c8fb-4353-851b-58d2ee082112" providerId="ADAL" clId="{8CCD629D-F3E0-1E40-91F1-70AE4173786F}" dt="2024-12-04T04:49:40.536" v="11" actId="164"/>
          <ac:picMkLst>
            <pc:docMk/>
            <pc:sldMk cId="3847332793" sldId="260"/>
            <ac:picMk id="6" creationId="{E9CEB3CD-C2DE-BF2A-63F3-C4C81B211D78}"/>
          </ac:picMkLst>
        </pc:picChg>
        <pc:picChg chg="mod">
          <ac:chgData name="Shirley Chang" userId="119bcda2-c8fb-4353-851b-58d2ee082112" providerId="ADAL" clId="{8CCD629D-F3E0-1E40-91F1-70AE4173786F}" dt="2024-12-04T04:50:02.139" v="16"/>
          <ac:picMkLst>
            <pc:docMk/>
            <pc:sldMk cId="3847332793" sldId="260"/>
            <ac:picMk id="7" creationId="{6939AC14-D13F-0DCB-198F-B5F7B5B9994B}"/>
          </ac:picMkLst>
        </pc:picChg>
        <pc:picChg chg="mod">
          <ac:chgData name="Shirley Chang" userId="119bcda2-c8fb-4353-851b-58d2ee082112" providerId="ADAL" clId="{8CCD629D-F3E0-1E40-91F1-70AE4173786F}" dt="2024-12-04T04:55:37.629" v="98" actId="14100"/>
          <ac:picMkLst>
            <pc:docMk/>
            <pc:sldMk cId="3847332793" sldId="260"/>
            <ac:picMk id="8" creationId="{EACF0AA6-518B-A2F8-835A-828C019755A8}"/>
          </ac:picMkLst>
        </pc:picChg>
      </pc:sldChg>
      <pc:sldChg chg="addSp modSp del mod">
        <pc:chgData name="Shirley Chang" userId="119bcda2-c8fb-4353-851b-58d2ee082112" providerId="ADAL" clId="{8CCD629D-F3E0-1E40-91F1-70AE4173786F}" dt="2024-12-04T10:40:04.740" v="145" actId="2696"/>
        <pc:sldMkLst>
          <pc:docMk/>
          <pc:sldMk cId="3023819268" sldId="263"/>
        </pc:sldMkLst>
      </pc:sldChg>
      <pc:sldChg chg="modSp mod">
        <pc:chgData name="Shirley Chang" userId="119bcda2-c8fb-4353-851b-58d2ee082112" providerId="ADAL" clId="{8CCD629D-F3E0-1E40-91F1-70AE4173786F}" dt="2024-12-04T10:42:21.198" v="146" actId="20577"/>
        <pc:sldMkLst>
          <pc:docMk/>
          <pc:sldMk cId="1288760415" sldId="264"/>
        </pc:sldMkLst>
        <pc:spChg chg="mod">
          <ac:chgData name="Shirley Chang" userId="119bcda2-c8fb-4353-851b-58d2ee082112" providerId="ADAL" clId="{8CCD629D-F3E0-1E40-91F1-70AE4173786F}" dt="2024-12-04T10:42:21.198" v="146" actId="20577"/>
          <ac:spMkLst>
            <pc:docMk/>
            <pc:sldMk cId="1288760415" sldId="264"/>
            <ac:spMk id="4" creationId="{0334A353-7019-8E59-7211-C84292492FA0}"/>
          </ac:spMkLst>
        </pc:spChg>
      </pc:sldChg>
      <pc:sldChg chg="modSp mod">
        <pc:chgData name="Shirley Chang" userId="119bcda2-c8fb-4353-851b-58d2ee082112" providerId="ADAL" clId="{8CCD629D-F3E0-1E40-91F1-70AE4173786F}" dt="2024-12-04T10:49:24.159" v="147" actId="20577"/>
        <pc:sldMkLst>
          <pc:docMk/>
          <pc:sldMk cId="2895816268" sldId="265"/>
        </pc:sldMkLst>
        <pc:spChg chg="mod">
          <ac:chgData name="Shirley Chang" userId="119bcda2-c8fb-4353-851b-58d2ee082112" providerId="ADAL" clId="{8CCD629D-F3E0-1E40-91F1-70AE4173786F}" dt="2024-12-04T10:49:24.159" v="147" actId="20577"/>
          <ac:spMkLst>
            <pc:docMk/>
            <pc:sldMk cId="2895816268" sldId="265"/>
            <ac:spMk id="5" creationId="{0334A353-7019-8E59-7211-C84292492FA0}"/>
          </ac:spMkLst>
        </pc:spChg>
      </pc:sldChg>
      <pc:sldChg chg="addSp delSp modSp new del mod">
        <pc:chgData name="Shirley Chang" userId="119bcda2-c8fb-4353-851b-58d2ee082112" providerId="ADAL" clId="{8CCD629D-F3E0-1E40-91F1-70AE4173786F}" dt="2024-12-04T10:49:26.371" v="148" actId="2696"/>
        <pc:sldMkLst>
          <pc:docMk/>
          <pc:sldMk cId="2601810559" sldId="266"/>
        </pc:sldMkLst>
      </pc:sldChg>
    </pc:docChg>
  </pc:docChgLst>
  <pc:docChgLst>
    <pc:chgData name="Shirley Chang" userId="119bcda2-c8fb-4353-851b-58d2ee082112" providerId="ADAL" clId="{45649F24-7872-8A42-8133-18150F622A70}"/>
    <pc:docChg chg="modSld">
      <pc:chgData name="Shirley Chang" userId="119bcda2-c8fb-4353-851b-58d2ee082112" providerId="ADAL" clId="{45649F24-7872-8A42-8133-18150F622A70}" dt="2025-04-17T07:34:30.113" v="49" actId="20577"/>
      <pc:docMkLst>
        <pc:docMk/>
      </pc:docMkLst>
      <pc:sldChg chg="addSp modSp mod">
        <pc:chgData name="Shirley Chang" userId="119bcda2-c8fb-4353-851b-58d2ee082112" providerId="ADAL" clId="{45649F24-7872-8A42-8133-18150F622A70}" dt="2025-04-17T07:34:30.113" v="49" actId="20577"/>
        <pc:sldMkLst>
          <pc:docMk/>
          <pc:sldMk cId="3847332793" sldId="260"/>
        </pc:sldMkLst>
        <pc:spChg chg="mod">
          <ac:chgData name="Shirley Chang" userId="119bcda2-c8fb-4353-851b-58d2ee082112" providerId="ADAL" clId="{45649F24-7872-8A42-8133-18150F622A70}" dt="2025-04-17T07:34:30.113" v="49" actId="20577"/>
          <ac:spMkLst>
            <pc:docMk/>
            <pc:sldMk cId="3847332793" sldId="260"/>
            <ac:spMk id="4" creationId="{5B5F7517-350F-0407-CBB6-34086BED3754}"/>
          </ac:spMkLst>
        </pc:spChg>
        <pc:graphicFrameChg chg="add mod">
          <ac:chgData name="Shirley Chang" userId="119bcda2-c8fb-4353-851b-58d2ee082112" providerId="ADAL" clId="{45649F24-7872-8A42-8133-18150F622A70}" dt="2025-04-17T07:33:21.682" v="3"/>
          <ac:graphicFrameMkLst>
            <pc:docMk/>
            <pc:sldMk cId="3847332793" sldId="260"/>
            <ac:graphicFrameMk id="13" creationId="{EBB92F0B-3F06-9351-FDFF-481EB25279D9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1F824-D8EC-4B1A-0B0F-35AD455F8B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B05923-46BF-C101-0AF1-4F05C57C7E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04E8DE-70D4-B986-786E-C9E9455DE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D3D7B4-BD45-485A-7D36-9B8775153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2FFDF3-B4FB-FAF0-BA34-DD1F71F4A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23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1EE2B-5848-F356-3299-98775C328F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860D28-3665-3AE9-299C-B7A4493069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A5B82B-D3FA-360D-FC8A-97F9CD92B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E954D3-DF24-EA7B-9029-BEA69ADF0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EECED-95EE-9A60-6295-EA7001951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224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10C4A6-5F46-E939-8FBA-19288DF3BD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92AA01-1332-DE98-56A4-8E0D0714EC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3EBCEC-CE5B-F40E-7409-B6280D14F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33EBE6-91F3-2E45-C37F-C48F2E144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EF6F1B-46BC-05CF-5C27-8E08A1F2F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12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4CCE58-98BA-9207-5244-C94D91C4AA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F7C11E-AC25-FC26-42FB-A3B7F929EE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FF57A0-B932-3641-8AFE-5E05A71C9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1DC9A6-72D4-C6DA-264B-5F195B225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169A82-FB52-4CAC-6D0B-A73B92F8B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405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4474A9-7CFC-F75A-7AEF-B5AEE564D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27048D-C280-A0F3-C7BD-1C4A4676B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F96B6A-DA2E-B5C4-ECD9-5B801FEEC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05ABB4-E4BD-BE3E-AB66-00F4B38EB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F7A270-22B0-5618-81BB-6C9D37A58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531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05B9D2-B8F0-83E9-82FB-A977BCD67F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27261E-0FA4-EF0C-E3DC-5D04524377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FF9C83-7779-9261-BB3F-77AA6F6C6A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37F9FE-4F05-059D-C02B-D636B7724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3C7CBD-B282-C1B6-5AFC-37D13D98D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9975E4-4F8C-35AB-3FF2-2221B2E03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712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5EE344-27EC-4607-8012-CD3C537BCF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DE68F3-541A-DC3A-7AB6-F18DA71635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B62883-6C4F-A077-978B-8BA58C521B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693232-6142-3467-E61C-B016844B96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D9EE92-20EB-364D-6023-1404ADDC63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DFE2500-18F8-642C-F763-C1E61CC5A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96A4CE-0AAB-B785-AE44-4F2ECE6E9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4F99F10-0635-44E2-B628-3BFC4CF32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641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3B464-36CC-557F-524A-7961E9FC8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DDBF39-24C6-974D-230B-CC4D0A50A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BCA4FE-6375-9037-9642-68BF22F37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1A1A55-140A-00EC-6502-BF68B0918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36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FE19CF2-92CE-5CDF-9DF9-26AF03312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E04A3D-55B6-3E71-65BE-5374A96B4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FA7414-BD5B-BC6C-010C-3B3516886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693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54B58-3344-84C9-C895-91A78F7D6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E6E1B2-3664-BE30-2C0C-F5606213C8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7F156B-5CF6-0266-45CB-08C60E532C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A1F86F-CAC5-A982-091E-FAEFC4EEA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88BAA8-1872-67EE-B167-2C99ADB4F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00F222-864C-5766-1FF4-F97D9E8C5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107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76F61-3905-A0E4-A6E3-575FDF60D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63D71A-E0A8-71ED-A18C-0BE9A8418B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EBB776-3DA7-1A26-F2AD-56C2376276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7D2F69-F46C-BC0C-51BC-909B74D39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05D858-F5AB-01B5-BD41-568967015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E59689-C995-612A-F43D-53C82FDE7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788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4205BE-6431-D236-948A-6D2D81591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D14999-7E44-8FAF-39D9-7AB48FE7B5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F58FC9-847C-7539-16A5-AFB81B8F8D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192B59-36F5-3948-82C1-A200001D100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03A894-2A52-32A2-54E7-C4E08BE675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E6E963-CA8C-5818-745E-454B99BD89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541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B5F7517-350F-0407-CBB6-34086BED3754}"/>
              </a:ext>
            </a:extLst>
          </p:cNvPr>
          <p:cNvSpPr txBox="1"/>
          <p:nvPr/>
        </p:nvSpPr>
        <p:spPr>
          <a:xfrm>
            <a:off x="0" y="-5777"/>
            <a:ext cx="121158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/>
              <a:t>Supplemental Figure 1.</a:t>
            </a:r>
            <a:r>
              <a:rPr lang="en-US" sz="1600"/>
              <a:t> </a:t>
            </a:r>
            <a:r>
              <a:rPr lang="en-AU" sz="1600" b="0" i="0">
                <a:effectLst/>
              </a:rPr>
              <a:t>PTB GWAS. </a:t>
            </a:r>
            <a:r>
              <a:rPr lang="en-AU" sz="1600" b="1" i="0">
                <a:effectLst/>
              </a:rPr>
              <a:t>a</a:t>
            </a:r>
            <a:r>
              <a:rPr lang="en-AU" sz="1600" b="0" i="0">
                <a:effectLst/>
              </a:rPr>
              <a:t> Manhattan plot of the GWAS analysis</a:t>
            </a:r>
            <a:r>
              <a:rPr lang="zh-CN" altLang="en-US" sz="1600" b="0" i="0">
                <a:effectLst/>
              </a:rPr>
              <a:t> </a:t>
            </a:r>
            <a:r>
              <a:rPr lang="en-AU" sz="1600" b="0" i="0">
                <a:effectLst/>
              </a:rPr>
              <a:t>in the Singapore Chinese Health Study</a:t>
            </a:r>
            <a:r>
              <a:rPr lang="en-US" sz="1600"/>
              <a:t> </a:t>
            </a:r>
            <a:r>
              <a:rPr lang="en-AU" sz="1600"/>
              <a:t>(SCHS, 1,610 cases/24,015 controls)</a:t>
            </a:r>
            <a:r>
              <a:rPr lang="en-AU" sz="1600" b="0" i="0">
                <a:effectLst/>
              </a:rPr>
              <a:t>. </a:t>
            </a:r>
            <a:r>
              <a:rPr lang="en-AU" sz="1600" b="1" i="0">
                <a:effectLst/>
              </a:rPr>
              <a:t>b</a:t>
            </a:r>
            <a:r>
              <a:rPr lang="en-AU" sz="1600" b="0" i="0">
                <a:effectLst/>
              </a:rPr>
              <a:t> QQ-plot of observed compared to expected </a:t>
            </a:r>
            <a:r>
              <a:rPr lang="en-AU" sz="1600" b="0" i="1">
                <a:effectLst/>
              </a:rPr>
              <a:t>P</a:t>
            </a:r>
            <a:r>
              <a:rPr lang="en-AU" sz="1600" b="0" i="0">
                <a:effectLst/>
              </a:rPr>
              <a:t>-values indicated minimal inflation (</a:t>
            </a:r>
            <a:r>
              <a:rPr lang="el-GR" sz="1600" b="0" i="1">
                <a:effectLst/>
              </a:rPr>
              <a:t>λ</a:t>
            </a:r>
            <a:r>
              <a:rPr lang="el-GR" sz="1600" b="0" i="0">
                <a:effectLst/>
              </a:rPr>
              <a:t> = 1.0</a:t>
            </a:r>
            <a:r>
              <a:rPr lang="en-AU" sz="1600" b="0" i="0">
                <a:effectLst/>
              </a:rPr>
              <a:t>07</a:t>
            </a:r>
            <a:r>
              <a:rPr lang="el-GR" sz="1600" b="0" i="0">
                <a:effectLst/>
              </a:rPr>
              <a:t>)</a:t>
            </a:r>
            <a:r>
              <a:rPr lang="en-AU" sz="1600" b="0" i="0">
                <a:effectLst/>
              </a:rPr>
              <a:t> in SCHS.</a:t>
            </a:r>
            <a:r>
              <a:rPr lang="en-AU" sz="1600" b="0" i="0">
                <a:solidFill>
                  <a:srgbClr val="222222"/>
                </a:solidFill>
                <a:effectLst/>
              </a:rPr>
              <a:t> </a:t>
            </a:r>
            <a:r>
              <a:rPr lang="en-AU" sz="1600" b="1">
                <a:solidFill>
                  <a:srgbClr val="222222"/>
                </a:solidFill>
              </a:rPr>
              <a:t>c</a:t>
            </a:r>
            <a:r>
              <a:rPr lang="en-AU" sz="1600" b="0" i="0">
                <a:solidFill>
                  <a:srgbClr val="222222"/>
                </a:solidFill>
                <a:effectLst/>
              </a:rPr>
              <a:t> Manhattan plot of the GWAS analysis in Vietnam (1,598 cases/1,267 controls). </a:t>
            </a:r>
            <a:r>
              <a:rPr lang="en-AU" sz="1600" b="1" i="0">
                <a:solidFill>
                  <a:srgbClr val="222222"/>
                </a:solidFill>
                <a:effectLst/>
              </a:rPr>
              <a:t>d</a:t>
            </a:r>
            <a:r>
              <a:rPr lang="en-AU" sz="1600" b="0" i="0">
                <a:solidFill>
                  <a:srgbClr val="222222"/>
                </a:solidFill>
                <a:effectLst/>
              </a:rPr>
              <a:t> QQ-plot of observed compared to expected </a:t>
            </a:r>
            <a:r>
              <a:rPr lang="en-AU" sz="1600" b="0" i="1">
                <a:solidFill>
                  <a:srgbClr val="222222"/>
                </a:solidFill>
                <a:effectLst/>
              </a:rPr>
              <a:t>P</a:t>
            </a:r>
            <a:r>
              <a:rPr lang="en-AU" sz="1600" b="0" i="0">
                <a:solidFill>
                  <a:srgbClr val="222222"/>
                </a:solidFill>
                <a:effectLst/>
              </a:rPr>
              <a:t>-values indicated minimal inflation (</a:t>
            </a:r>
            <a:r>
              <a:rPr lang="el-GR" sz="1600" b="0" i="1">
                <a:solidFill>
                  <a:srgbClr val="222222"/>
                </a:solidFill>
                <a:effectLst/>
              </a:rPr>
              <a:t>λ</a:t>
            </a:r>
            <a:r>
              <a:rPr lang="el-GR" sz="1600" b="0" i="0">
                <a:solidFill>
                  <a:srgbClr val="222222"/>
                </a:solidFill>
                <a:effectLst/>
              </a:rPr>
              <a:t> = </a:t>
            </a:r>
            <a:r>
              <a:rPr lang="en-AU" sz="1600">
                <a:solidFill>
                  <a:srgbClr val="222222"/>
                </a:solidFill>
              </a:rPr>
              <a:t>0.985</a:t>
            </a:r>
            <a:r>
              <a:rPr lang="el-GR" sz="1600" b="0" i="0">
                <a:solidFill>
                  <a:srgbClr val="222222"/>
                </a:solidFill>
                <a:effectLst/>
              </a:rPr>
              <a:t>)</a:t>
            </a:r>
            <a:r>
              <a:rPr lang="en-AU" sz="1600" b="0" i="0">
                <a:solidFill>
                  <a:srgbClr val="222222"/>
                </a:solidFill>
                <a:effectLst/>
              </a:rPr>
              <a:t> in Vietnam</a:t>
            </a:r>
            <a:r>
              <a:rPr lang="en-AU" sz="1600">
                <a:solidFill>
                  <a:srgbClr val="222222"/>
                </a:solidFill>
              </a:rPr>
              <a:t>.</a:t>
            </a:r>
            <a:endParaRPr lang="en-US" sz="1600">
              <a:solidFill>
                <a:srgbClr val="FF0000"/>
              </a:solidFill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49EECFC-ECD3-178F-560D-D2B58F56D6A3}"/>
              </a:ext>
            </a:extLst>
          </p:cNvPr>
          <p:cNvGrpSpPr/>
          <p:nvPr/>
        </p:nvGrpSpPr>
        <p:grpSpPr>
          <a:xfrm>
            <a:off x="22070" y="1062132"/>
            <a:ext cx="6151419" cy="3503930"/>
            <a:chOff x="70338" y="446650"/>
            <a:chExt cx="10363200" cy="6411350"/>
          </a:xfrm>
        </p:grpSpPr>
        <p:pic>
          <p:nvPicPr>
            <p:cNvPr id="6" name="Picture 5" descr="A graph showing a number of different colored bars&#10;&#10;Description automatically generated with medium confidence">
              <a:extLst>
                <a:ext uri="{FF2B5EF4-FFF2-40B4-BE49-F238E27FC236}">
                  <a16:creationId xmlns:a16="http://schemas.microsoft.com/office/drawing/2014/main" id="{E9CEB3CD-C2DE-BF2A-63F3-C4C81B211D7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0338" y="1676400"/>
              <a:ext cx="10363200" cy="5181600"/>
            </a:xfrm>
            <a:prstGeom prst="rect">
              <a:avLst/>
            </a:prstGeom>
          </p:spPr>
        </p:pic>
        <p:pic>
          <p:nvPicPr>
            <p:cNvPr id="8" name="Picture 7" descr="A graph of a graph&#10;&#10;Description automatically generated">
              <a:extLst>
                <a:ext uri="{FF2B5EF4-FFF2-40B4-BE49-F238E27FC236}">
                  <a16:creationId xmlns:a16="http://schemas.microsoft.com/office/drawing/2014/main" id="{EACF0AA6-518B-A2F8-835A-828C019755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474674" y="446652"/>
              <a:ext cx="2236215" cy="2236213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3696138-C610-B74F-99B0-9B192F79A4B1}"/>
                </a:ext>
              </a:extLst>
            </p:cNvPr>
            <p:cNvSpPr txBox="1"/>
            <p:nvPr/>
          </p:nvSpPr>
          <p:spPr>
            <a:xfrm>
              <a:off x="287586" y="1524966"/>
              <a:ext cx="684929" cy="5631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a.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330F99C-EBBE-D41E-55BA-4D1CC537D92F}"/>
                </a:ext>
              </a:extLst>
            </p:cNvPr>
            <p:cNvSpPr txBox="1"/>
            <p:nvPr/>
          </p:nvSpPr>
          <p:spPr>
            <a:xfrm>
              <a:off x="7180577" y="446650"/>
              <a:ext cx="588194" cy="5631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b.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28773F12-D66E-D721-7FB1-CAA6DAF4F8D8}"/>
              </a:ext>
            </a:extLst>
          </p:cNvPr>
          <p:cNvGrpSpPr/>
          <p:nvPr/>
        </p:nvGrpSpPr>
        <p:grpSpPr>
          <a:xfrm>
            <a:off x="5901153" y="1062132"/>
            <a:ext cx="6330426" cy="3503929"/>
            <a:chOff x="0" y="469704"/>
            <a:chExt cx="10550769" cy="6388295"/>
          </a:xfrm>
        </p:grpSpPr>
        <p:pic>
          <p:nvPicPr>
            <p:cNvPr id="5" name="Picture 4" descr="A graph showing a number of different colored lines&#10;&#10;Description automatically generated with medium confidence">
              <a:extLst>
                <a:ext uri="{FF2B5EF4-FFF2-40B4-BE49-F238E27FC236}">
                  <a16:creationId xmlns:a16="http://schemas.microsoft.com/office/drawing/2014/main" id="{94337381-1927-78F1-FDF7-64033AE72B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1582614"/>
              <a:ext cx="10550769" cy="5275385"/>
            </a:xfrm>
            <a:prstGeom prst="rect">
              <a:avLst/>
            </a:prstGeom>
          </p:spPr>
        </p:pic>
        <p:pic>
          <p:nvPicPr>
            <p:cNvPr id="7" name="Picture 6" descr="A graph of a graph&#10;&#10;Description automatically generated">
              <a:extLst>
                <a:ext uri="{FF2B5EF4-FFF2-40B4-BE49-F238E27FC236}">
                  <a16:creationId xmlns:a16="http://schemas.microsoft.com/office/drawing/2014/main" id="{6939AC14-D13F-0DCB-198F-B5F7B5B9994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137377" y="469704"/>
              <a:ext cx="2413392" cy="2413392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0682AA1-C55C-6AC7-6385-0B6927EED112}"/>
                </a:ext>
              </a:extLst>
            </p:cNvPr>
            <p:cNvSpPr txBox="1"/>
            <p:nvPr/>
          </p:nvSpPr>
          <p:spPr>
            <a:xfrm>
              <a:off x="262726" y="1477568"/>
              <a:ext cx="706887" cy="568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c.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1C9FE6E-5593-8429-6FB2-C1D140897655}"/>
                </a:ext>
              </a:extLst>
            </p:cNvPr>
            <p:cNvSpPr txBox="1"/>
            <p:nvPr/>
          </p:nvSpPr>
          <p:spPr>
            <a:xfrm>
              <a:off x="7856134" y="524713"/>
              <a:ext cx="562485" cy="5758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d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473327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34A353-7019-8E59-7211-C84292492FA0}"/>
              </a:ext>
            </a:extLst>
          </p:cNvPr>
          <p:cNvSpPr txBox="1"/>
          <p:nvPr/>
        </p:nvSpPr>
        <p:spPr>
          <a:xfrm>
            <a:off x="128954" y="122617"/>
            <a:ext cx="120630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Supplemental Figure </a:t>
            </a:r>
            <a:r>
              <a:rPr lang="en-US" altLang="zh-CN" b="1"/>
              <a:t>2</a:t>
            </a:r>
            <a:r>
              <a:rPr lang="en-US" b="1"/>
              <a:t>.</a:t>
            </a:r>
            <a:r>
              <a:rPr lang="en-US"/>
              <a:t> Significant differential expression of candidate genes within ±400kb of rs6006426 in monocytes from Singaporean pulmonary tuberculosis patients (comprising Chinese, Malay, and Indian ethnicities).</a:t>
            </a:r>
            <a:endParaRPr lang="en-US">
              <a:solidFill>
                <a:srgbClr val="FF0000"/>
              </a:solidFill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37C2EAF-F7F9-9478-4FE4-09288D5CF20B}"/>
              </a:ext>
            </a:extLst>
          </p:cNvPr>
          <p:cNvGrpSpPr/>
          <p:nvPr/>
        </p:nvGrpSpPr>
        <p:grpSpPr>
          <a:xfrm>
            <a:off x="92706" y="1335618"/>
            <a:ext cx="5756845" cy="6401367"/>
            <a:chOff x="92706" y="1335618"/>
            <a:chExt cx="5756845" cy="6401367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756C74A-49E1-F25F-AEFA-10A8A603282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2706" y="4678778"/>
              <a:ext cx="2621320" cy="305820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9F912E4-E594-732D-07D1-7843D26046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2706" y="1335618"/>
              <a:ext cx="2621321" cy="3047285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D63F7DD-8FC8-9F00-84FE-578E656E24D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28230" y="1335618"/>
              <a:ext cx="2621321" cy="3047285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B117B72C-B9EF-1CB9-6332-C65063B26A5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92273" y="4678778"/>
              <a:ext cx="2610398" cy="304728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887604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0334A353-7019-8E59-7211-C84292492FA0}"/>
              </a:ext>
            </a:extLst>
          </p:cNvPr>
          <p:cNvSpPr txBox="1"/>
          <p:nvPr/>
        </p:nvSpPr>
        <p:spPr>
          <a:xfrm>
            <a:off x="64477" y="145464"/>
            <a:ext cx="120630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/>
              <a:t>Supplemental Figure </a:t>
            </a:r>
            <a:r>
              <a:rPr lang="en-US" altLang="zh-CN" b="1"/>
              <a:t>3</a:t>
            </a:r>
            <a:r>
              <a:rPr lang="en-US" b="1"/>
              <a:t>.</a:t>
            </a:r>
            <a:r>
              <a:rPr lang="en-US"/>
              <a:t> Functional analysis of </a:t>
            </a:r>
            <a:r>
              <a:rPr lang="en-US" i="1"/>
              <a:t>sf3a1</a:t>
            </a:r>
            <a:r>
              <a:rPr lang="en-US"/>
              <a:t> in the zebrafish-</a:t>
            </a:r>
            <a:r>
              <a:rPr lang="en-US" i="1"/>
              <a:t>M. </a:t>
            </a:r>
            <a:r>
              <a:rPr lang="en-US" i="1" err="1"/>
              <a:t>marinum</a:t>
            </a:r>
            <a:r>
              <a:rPr lang="en-US" i="1"/>
              <a:t> </a:t>
            </a:r>
            <a:r>
              <a:rPr lang="en-US"/>
              <a:t>infection model. </a:t>
            </a:r>
            <a:r>
              <a:rPr lang="en-US" b="1"/>
              <a:t>a.</a:t>
            </a:r>
            <a:r>
              <a:rPr lang="en-US"/>
              <a:t> </a:t>
            </a:r>
            <a:r>
              <a:rPr lang="en-US" i="1"/>
              <a:t>M. </a:t>
            </a:r>
            <a:r>
              <a:rPr lang="en-US" i="1" err="1"/>
              <a:t>marinum</a:t>
            </a:r>
            <a:r>
              <a:rPr lang="en-US"/>
              <a:t> infection burden in </a:t>
            </a:r>
            <a:r>
              <a:rPr lang="en-US" i="1"/>
              <a:t>sf3a1</a:t>
            </a:r>
            <a:r>
              <a:rPr lang="en-US"/>
              <a:t> knockdown zebrafish embryos; </a:t>
            </a:r>
            <a:r>
              <a:rPr lang="en-US" b="1"/>
              <a:t>b.</a:t>
            </a:r>
            <a:r>
              <a:rPr lang="en-US"/>
              <a:t> Embryo morphology in 2 day post </a:t>
            </a:r>
            <a:r>
              <a:rPr lang="en-US" err="1"/>
              <a:t>fertilisation</a:t>
            </a:r>
            <a:r>
              <a:rPr lang="en-US"/>
              <a:t> </a:t>
            </a:r>
            <a:r>
              <a:rPr lang="en-US" i="1"/>
              <a:t>sf3a1</a:t>
            </a:r>
            <a:r>
              <a:rPr lang="en-US"/>
              <a:t> knockdown; </a:t>
            </a:r>
            <a:r>
              <a:rPr lang="en-US" b="1"/>
              <a:t>c.</a:t>
            </a:r>
            <a:r>
              <a:rPr lang="en-US"/>
              <a:t> </a:t>
            </a:r>
            <a:r>
              <a:rPr lang="en-US" i="1"/>
              <a:t>M. </a:t>
            </a:r>
            <a:r>
              <a:rPr lang="en-US" i="1" err="1"/>
              <a:t>marinum</a:t>
            </a:r>
            <a:r>
              <a:rPr lang="en-US"/>
              <a:t> infection burden in low-dose </a:t>
            </a:r>
            <a:r>
              <a:rPr lang="en-US" i="1"/>
              <a:t>sf3a1</a:t>
            </a:r>
            <a:r>
              <a:rPr lang="en-US"/>
              <a:t> knockdown zebrafish embryos.</a:t>
            </a:r>
            <a:endParaRPr lang="en-US">
              <a:solidFill>
                <a:srgbClr val="FF0000"/>
              </a:solidFill>
            </a:endParaRPr>
          </a:p>
        </p:txBody>
      </p:sp>
      <p:pic>
        <p:nvPicPr>
          <p:cNvPr id="7" name="Picture 6" descr="A close-up of several images of a sperm&#10;&#10;Description automatically generated">
            <a:extLst>
              <a:ext uri="{FF2B5EF4-FFF2-40B4-BE49-F238E27FC236}">
                <a16:creationId xmlns:a16="http://schemas.microsoft.com/office/drawing/2014/main" id="{588BCEF2-9FBB-9BC1-8F72-6FA5387371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769" y="1396546"/>
            <a:ext cx="9903594" cy="40649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5816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Application>Microsoft Office PowerPoint</Application>
  <PresentationFormat>Widescreen</PresentationFormat>
  <Slides>3</Slides>
  <Notes>0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rley Chang</dc:creator>
  <cp:revision>1</cp:revision>
  <dcterms:created xsi:type="dcterms:W3CDTF">2023-11-20T05:33:37Z</dcterms:created>
  <dcterms:modified xsi:type="dcterms:W3CDTF">2025-04-17T07:34:45Z</dcterms:modified>
</cp:coreProperties>
</file>